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28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lison Graper" userId="b6ea7f156f7cc013" providerId="LiveId" clId="{9B725485-55AF-4AFB-BE45-4D090B22ED35}"/>
    <pc:docChg chg="modSld">
      <pc:chgData name="Allison Graper" userId="b6ea7f156f7cc013" providerId="LiveId" clId="{9B725485-55AF-4AFB-BE45-4D090B22ED35}" dt="2021-01-30T00:32:17.434" v="0" actId="1076"/>
      <pc:docMkLst>
        <pc:docMk/>
      </pc:docMkLst>
      <pc:sldChg chg="modSp mod">
        <pc:chgData name="Allison Graper" userId="b6ea7f156f7cc013" providerId="LiveId" clId="{9B725485-55AF-4AFB-BE45-4D090B22ED35}" dt="2021-01-30T00:32:17.434" v="0" actId="1076"/>
        <pc:sldMkLst>
          <pc:docMk/>
          <pc:sldMk cId="2761414179" sldId="258"/>
        </pc:sldMkLst>
        <pc:spChg chg="mod">
          <ac:chgData name="Allison Graper" userId="b6ea7f156f7cc013" providerId="LiveId" clId="{9B725485-55AF-4AFB-BE45-4D090B22ED35}" dt="2021-01-30T00:32:17.434" v="0" actId="1076"/>
          <ac:spMkLst>
            <pc:docMk/>
            <pc:sldMk cId="2761414179" sldId="258"/>
            <ac:spMk id="2" creationId="{8FA6C2C9-9D0E-4693-BA77-F62A98577AC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360398-4855-4789-8130-8C29B5F038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7640823-651C-4762-AF84-9BB116BF04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1AE2FC-FE2B-480B-845B-C28F28C32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C3A0D-F33C-4DC8-90B5-509D1DA4B2A4}" type="datetimeFigureOut">
              <a:rPr lang="en-US" smtClean="0"/>
              <a:t>2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FB0929-3BDD-4E2A-93EC-B3C7BD348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9CB55F-32A8-492D-A4F0-D5DF867F9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3C9B-6221-42A1-AF40-EAE4A98C18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050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C02AE6-54CB-447F-863D-294565F9FF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C6BCAE-9BE3-4068-84FD-1046DFBF5B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F3AB70-D07B-40CB-A374-88692BBDC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C3A0D-F33C-4DC8-90B5-509D1DA4B2A4}" type="datetimeFigureOut">
              <a:rPr lang="en-US" smtClean="0"/>
              <a:t>2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B2F21D-6280-4803-81B2-D7105CE07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213B10-D7AE-47F1-B258-A03B45955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3C9B-6221-42A1-AF40-EAE4A98C18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967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5403C6-7B69-4812-8411-73FA71AEF9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33919A-440A-46E9-ACF6-F458CA771A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2D2F10-081D-4033-8870-B78E160C3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C3A0D-F33C-4DC8-90B5-509D1DA4B2A4}" type="datetimeFigureOut">
              <a:rPr lang="en-US" smtClean="0"/>
              <a:t>2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0E51D2-2FFA-41EF-872C-AB6606A71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E08C3B-ACF7-4942-ADE1-9AEF24FCA1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3C9B-6221-42A1-AF40-EAE4A98C18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2193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EEF4F-AB3D-4336-93BD-4F64BC2402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B5397B-65B2-435C-B43D-EDB669BB83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E4F3E3-8D09-4B4E-9301-2FC6FADC9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C3A0D-F33C-4DC8-90B5-509D1DA4B2A4}" type="datetimeFigureOut">
              <a:rPr lang="en-US" smtClean="0"/>
              <a:t>2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279BBC-0A91-4B76-8084-6C7974013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5B7A6B-4DC8-4B1A-9796-412AC13B0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3C9B-6221-42A1-AF40-EAE4A98C18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367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D94B8E-D7C3-4C81-804A-432FA6A2E8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3C9E7F-DC0C-40D3-B400-C0384145CF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218B00-204B-4406-A909-3CFA497215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C3A0D-F33C-4DC8-90B5-509D1DA4B2A4}" type="datetimeFigureOut">
              <a:rPr lang="en-US" smtClean="0"/>
              <a:t>2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08AF7C-D08A-4EE3-B75B-EFB65FA88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5E528C-AF67-4612-847B-AD1952E3C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3C9B-6221-42A1-AF40-EAE4A98C18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979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1AC6B9-0D82-4EDB-8AB3-0CA0315084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8CEDA0-991B-4EC6-BA52-6811AB0F82F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7624A2-0B98-44B0-AAC8-62C6D2AEEE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EEA440-35C8-429F-8BEA-55B401A05A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C3A0D-F33C-4DC8-90B5-509D1DA4B2A4}" type="datetimeFigureOut">
              <a:rPr lang="en-US" smtClean="0"/>
              <a:t>2/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DB419A-1DF1-4E16-8509-7072CEA82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88956E-5ABA-46E4-8675-FCBA4843B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3C9B-6221-42A1-AF40-EAE4A98C18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334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D293E5-7C43-494A-95DC-407C865D6F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C0C9CC-EEF8-49E0-A531-9541129DBD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933F90-6E24-4C0F-9F87-8DF098669F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1AA64E-0499-4A5C-98D7-EC91741539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15E62E7-027A-4662-A5A3-82425E0AEE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3E4C93C-F5D2-428C-BA6A-C5C2FEF9A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C3A0D-F33C-4DC8-90B5-509D1DA4B2A4}" type="datetimeFigureOut">
              <a:rPr lang="en-US" smtClean="0"/>
              <a:t>2/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714E525-F824-4438-9F8B-9E3AB2F49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769E2F4-D2E9-4F67-A9C6-329DE5C2C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3C9B-6221-42A1-AF40-EAE4A98C18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446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064748-BC82-42E6-9D82-D6606E71D3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DDCCFEC-52F0-4D9C-B4A2-9AC191C43B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C3A0D-F33C-4DC8-90B5-509D1DA4B2A4}" type="datetimeFigureOut">
              <a:rPr lang="en-US" smtClean="0"/>
              <a:t>2/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A3F989-E630-4B4A-9B81-75F4D1EF4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93ED3A8-C9BA-4E1D-B667-F8479A454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3C9B-6221-42A1-AF40-EAE4A98C18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50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0294B1D-3784-4744-90A8-A36085C4D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C3A0D-F33C-4DC8-90B5-509D1DA4B2A4}" type="datetimeFigureOut">
              <a:rPr lang="en-US" smtClean="0"/>
              <a:t>2/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EC7EE4A-A277-4297-8956-4224560C0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678CF5-0C04-4989-B1DE-7F3D89423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3C9B-6221-42A1-AF40-EAE4A98C18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562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AD2190-C77E-43E2-A12B-C05A9F88F7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56869D-CB56-4773-BA60-3D3B259F8C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6FB29C-5908-4833-B955-CC93AA245F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E77760-93A5-465C-BD6D-55967FFB85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C3A0D-F33C-4DC8-90B5-509D1DA4B2A4}" type="datetimeFigureOut">
              <a:rPr lang="en-US" smtClean="0"/>
              <a:t>2/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07757C-F379-414F-931C-19792B3C6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DBC434-C9C9-48F7-8D52-4B892C201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3C9B-6221-42A1-AF40-EAE4A98C18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036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32989-7058-4615-876D-7AFEEDDFEC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AB94988-2DCE-4A95-A650-98951F29FE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29816C-BCC0-4606-B12C-011364F322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126DF8-ECEC-4BDC-89E7-3E8426685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FC3A0D-F33C-4DC8-90B5-509D1DA4B2A4}" type="datetimeFigureOut">
              <a:rPr lang="en-US" smtClean="0"/>
              <a:t>2/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A1FE83-733D-4E2C-95FE-8C76242A6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A32C0F-0F2D-40ED-AE22-2B63FDE463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E3C9B-6221-42A1-AF40-EAE4A98C18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048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6F715A4-4FF7-42A3-A44E-0B45340E57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2B6916-5B1B-47FB-82B7-2BBA27D793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22F665-7FC8-4009-AB59-891BDB2973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FC3A0D-F33C-4DC8-90B5-509D1DA4B2A4}" type="datetimeFigureOut">
              <a:rPr lang="en-US" smtClean="0"/>
              <a:t>2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F3224B-6C2D-43A7-88B7-475A111669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33B2AE-8948-4DA1-A1E2-163E94EFE1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3E3C9B-6221-42A1-AF40-EAE4A98C18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953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3">
            <a:extLst>
              <a:ext uri="{FF2B5EF4-FFF2-40B4-BE49-F238E27FC236}">
                <a16:creationId xmlns:a16="http://schemas.microsoft.com/office/drawing/2014/main" id="{8FA6C2C9-9D0E-4693-BA77-F62A98577ACB}"/>
              </a:ext>
            </a:extLst>
          </p:cNvPr>
          <p:cNvSpPr txBox="1">
            <a:spLocks/>
          </p:cNvSpPr>
          <p:nvPr/>
        </p:nvSpPr>
        <p:spPr>
          <a:xfrm>
            <a:off x="838200" y="394942"/>
            <a:ext cx="10515600" cy="132556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bility in ITS1 and ITS2 sequences of historic (herbaria) and extant (fresh)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laris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. (Graper, Noyszewski, Anderson, Smith). 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7614141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4B90DFB4-E44E-47A7-A2E4-5C744775368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0447009"/>
              </p:ext>
            </p:extLst>
          </p:nvPr>
        </p:nvGraphicFramePr>
        <p:xfrm>
          <a:off x="4316095" y="446004"/>
          <a:ext cx="3655773" cy="370840"/>
        </p:xfrm>
        <a:graphic>
          <a:graphicData uri="http://schemas.openxmlformats.org/drawingml/2006/table">
            <a:tbl>
              <a:tblPr firstRow="1" bandRow="1"/>
              <a:tblGrid>
                <a:gridCol w="332343">
                  <a:extLst>
                    <a:ext uri="{9D8B030D-6E8A-4147-A177-3AD203B41FA5}">
                      <a16:colId xmlns:a16="http://schemas.microsoft.com/office/drawing/2014/main" val="1898140017"/>
                    </a:ext>
                  </a:extLst>
                </a:gridCol>
                <a:gridCol w="332343">
                  <a:extLst>
                    <a:ext uri="{9D8B030D-6E8A-4147-A177-3AD203B41FA5}">
                      <a16:colId xmlns:a16="http://schemas.microsoft.com/office/drawing/2014/main" val="1326489592"/>
                    </a:ext>
                  </a:extLst>
                </a:gridCol>
                <a:gridCol w="332343">
                  <a:extLst>
                    <a:ext uri="{9D8B030D-6E8A-4147-A177-3AD203B41FA5}">
                      <a16:colId xmlns:a16="http://schemas.microsoft.com/office/drawing/2014/main" val="63476478"/>
                    </a:ext>
                  </a:extLst>
                </a:gridCol>
                <a:gridCol w="332343">
                  <a:extLst>
                    <a:ext uri="{9D8B030D-6E8A-4147-A177-3AD203B41FA5}">
                      <a16:colId xmlns:a16="http://schemas.microsoft.com/office/drawing/2014/main" val="2890943238"/>
                    </a:ext>
                  </a:extLst>
                </a:gridCol>
                <a:gridCol w="332343">
                  <a:extLst>
                    <a:ext uri="{9D8B030D-6E8A-4147-A177-3AD203B41FA5}">
                      <a16:colId xmlns:a16="http://schemas.microsoft.com/office/drawing/2014/main" val="194366151"/>
                    </a:ext>
                  </a:extLst>
                </a:gridCol>
                <a:gridCol w="332343">
                  <a:extLst>
                    <a:ext uri="{9D8B030D-6E8A-4147-A177-3AD203B41FA5}">
                      <a16:colId xmlns:a16="http://schemas.microsoft.com/office/drawing/2014/main" val="1625692347"/>
                    </a:ext>
                  </a:extLst>
                </a:gridCol>
                <a:gridCol w="332343">
                  <a:extLst>
                    <a:ext uri="{9D8B030D-6E8A-4147-A177-3AD203B41FA5}">
                      <a16:colId xmlns:a16="http://schemas.microsoft.com/office/drawing/2014/main" val="1844474478"/>
                    </a:ext>
                  </a:extLst>
                </a:gridCol>
                <a:gridCol w="332343">
                  <a:extLst>
                    <a:ext uri="{9D8B030D-6E8A-4147-A177-3AD203B41FA5}">
                      <a16:colId xmlns:a16="http://schemas.microsoft.com/office/drawing/2014/main" val="2155395871"/>
                    </a:ext>
                  </a:extLst>
                </a:gridCol>
                <a:gridCol w="332343">
                  <a:extLst>
                    <a:ext uri="{9D8B030D-6E8A-4147-A177-3AD203B41FA5}">
                      <a16:colId xmlns:a16="http://schemas.microsoft.com/office/drawing/2014/main" val="277644112"/>
                    </a:ext>
                  </a:extLst>
                </a:gridCol>
                <a:gridCol w="332343">
                  <a:extLst>
                    <a:ext uri="{9D8B030D-6E8A-4147-A177-3AD203B41FA5}">
                      <a16:colId xmlns:a16="http://schemas.microsoft.com/office/drawing/2014/main" val="2847478090"/>
                    </a:ext>
                  </a:extLst>
                </a:gridCol>
                <a:gridCol w="332343">
                  <a:extLst>
                    <a:ext uri="{9D8B030D-6E8A-4147-A177-3AD203B41FA5}">
                      <a16:colId xmlns:a16="http://schemas.microsoft.com/office/drawing/2014/main" val="281640348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84461349"/>
                  </a:ext>
                </a:extLst>
              </a:tr>
            </a:tbl>
          </a:graphicData>
        </a:graphic>
      </p:graphicFrame>
      <p:grpSp>
        <p:nvGrpSpPr>
          <p:cNvPr id="10" name="Group 9">
            <a:extLst>
              <a:ext uri="{FF2B5EF4-FFF2-40B4-BE49-F238E27FC236}">
                <a16:creationId xmlns:a16="http://schemas.microsoft.com/office/drawing/2014/main" id="{02D64B44-A7E4-48D8-A475-8C638B072A59}"/>
              </a:ext>
            </a:extLst>
          </p:cNvPr>
          <p:cNvGrpSpPr/>
          <p:nvPr/>
        </p:nvGrpSpPr>
        <p:grpSpPr>
          <a:xfrm>
            <a:off x="3549099" y="816845"/>
            <a:ext cx="4954141" cy="5224309"/>
            <a:chOff x="3270803" y="1633691"/>
            <a:chExt cx="4954141" cy="5224309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802FB76-7ED6-4570-9B54-6FB3A38E61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03" t="-190" r="-722" b="-288"/>
            <a:stretch/>
          </p:blipFill>
          <p:spPr>
            <a:xfrm rot="16200000">
              <a:off x="3507532" y="2140588"/>
              <a:ext cx="5224309" cy="421051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1B02356-D92C-4323-B5BF-21C08BCD24C9}"/>
                </a:ext>
              </a:extLst>
            </p:cNvPr>
            <p:cNvSpPr txBox="1"/>
            <p:nvPr/>
          </p:nvSpPr>
          <p:spPr>
            <a:xfrm>
              <a:off x="3270803" y="2900288"/>
              <a:ext cx="628497" cy="2769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bp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6493FDD-4C46-4FA9-AA53-18A560ED3109}"/>
                </a:ext>
              </a:extLst>
            </p:cNvPr>
            <p:cNvSpPr txBox="1"/>
            <p:nvPr/>
          </p:nvSpPr>
          <p:spPr>
            <a:xfrm>
              <a:off x="3311234" y="4795474"/>
              <a:ext cx="635125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0 bp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20F2BC0-477C-4A7B-9986-0B03F8E7EFBE}"/>
                </a:ext>
              </a:extLst>
            </p:cNvPr>
            <p:cNvSpPr txBox="1"/>
            <p:nvPr/>
          </p:nvSpPr>
          <p:spPr>
            <a:xfrm>
              <a:off x="3390748" y="3986384"/>
              <a:ext cx="555611" cy="2769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bp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41BC6A5-9451-46D9-82FA-2849C6FE2D4F}"/>
                </a:ext>
              </a:extLst>
            </p:cNvPr>
            <p:cNvSpPr txBox="1"/>
            <p:nvPr/>
          </p:nvSpPr>
          <p:spPr>
            <a:xfrm>
              <a:off x="3302603" y="5316701"/>
              <a:ext cx="6246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 bp</a:t>
              </a:r>
            </a:p>
          </p:txBody>
        </p: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00BE0619-87F6-4B24-BDD8-863273959943}"/>
                </a:ext>
              </a:extLst>
            </p:cNvPr>
            <p:cNvCxnSpPr/>
            <p:nvPr/>
          </p:nvCxnSpPr>
          <p:spPr>
            <a:xfrm>
              <a:off x="3807860" y="3038784"/>
              <a:ext cx="18288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FEEB4B8E-814A-4CFC-AC42-C355D8E23F68}"/>
                </a:ext>
              </a:extLst>
            </p:cNvPr>
            <p:cNvCxnSpPr/>
            <p:nvPr/>
          </p:nvCxnSpPr>
          <p:spPr>
            <a:xfrm>
              <a:off x="3854919" y="4141380"/>
              <a:ext cx="18288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764FA3E6-7683-45E2-93E2-83EC8E713F82}"/>
                </a:ext>
              </a:extLst>
            </p:cNvPr>
            <p:cNvCxnSpPr/>
            <p:nvPr/>
          </p:nvCxnSpPr>
          <p:spPr>
            <a:xfrm>
              <a:off x="3835855" y="4950410"/>
              <a:ext cx="18288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770C51A6-D9E3-4FB2-BA6E-2E781406A465}"/>
                </a:ext>
              </a:extLst>
            </p:cNvPr>
            <p:cNvCxnSpPr/>
            <p:nvPr/>
          </p:nvCxnSpPr>
          <p:spPr>
            <a:xfrm>
              <a:off x="3835855" y="5455201"/>
              <a:ext cx="18288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8C565F4-C4B8-4A67-80DA-C60181AB5D59}"/>
              </a:ext>
            </a:extLst>
          </p:cNvPr>
          <p:cNvCxnSpPr>
            <a:cxnSpLocks/>
          </p:cNvCxnSpPr>
          <p:nvPr/>
        </p:nvCxnSpPr>
        <p:spPr>
          <a:xfrm>
            <a:off x="8071026" y="2014301"/>
            <a:ext cx="0" cy="3200429"/>
          </a:xfrm>
          <a:prstGeom prst="line">
            <a:avLst/>
          </a:prstGeom>
          <a:ln w="1905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BA22F735-4FD9-4047-B269-37ACD1983285}"/>
              </a:ext>
            </a:extLst>
          </p:cNvPr>
          <p:cNvCxnSpPr>
            <a:cxnSpLocks/>
          </p:cNvCxnSpPr>
          <p:nvPr/>
        </p:nvCxnSpPr>
        <p:spPr>
          <a:xfrm flipH="1">
            <a:off x="4316096" y="5214730"/>
            <a:ext cx="3754930" cy="0"/>
          </a:xfrm>
          <a:prstGeom prst="line">
            <a:avLst/>
          </a:prstGeom>
          <a:ln w="1905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9F77D60F-27AF-4473-BC01-6B3836FB7A7A}"/>
              </a:ext>
            </a:extLst>
          </p:cNvPr>
          <p:cNvCxnSpPr>
            <a:cxnSpLocks/>
          </p:cNvCxnSpPr>
          <p:nvPr/>
        </p:nvCxnSpPr>
        <p:spPr>
          <a:xfrm flipH="1">
            <a:off x="4316095" y="1994034"/>
            <a:ext cx="3778620" cy="13064"/>
          </a:xfrm>
          <a:prstGeom prst="line">
            <a:avLst/>
          </a:prstGeom>
          <a:ln w="1905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EF68D0CF-9005-4FF0-96D3-6B0EDDA4DA01}"/>
              </a:ext>
            </a:extLst>
          </p:cNvPr>
          <p:cNvCxnSpPr>
            <a:cxnSpLocks/>
          </p:cNvCxnSpPr>
          <p:nvPr/>
        </p:nvCxnSpPr>
        <p:spPr>
          <a:xfrm>
            <a:off x="4316095" y="1994034"/>
            <a:ext cx="0" cy="3200429"/>
          </a:xfrm>
          <a:prstGeom prst="line">
            <a:avLst/>
          </a:prstGeom>
          <a:ln w="1905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23319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1</TotalTime>
  <Words>50</Words>
  <Application>Microsoft Macintosh PowerPoint</Application>
  <PresentationFormat>Widescreen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lison Graper</dc:creator>
  <cp:lastModifiedBy>Neil O Anderson</cp:lastModifiedBy>
  <cp:revision>8</cp:revision>
  <dcterms:created xsi:type="dcterms:W3CDTF">2021-01-11T00:53:44Z</dcterms:created>
  <dcterms:modified xsi:type="dcterms:W3CDTF">2021-02-01T12:24:48Z</dcterms:modified>
</cp:coreProperties>
</file>